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95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wmf" ContentType="image/x-wmf"/>
  <Override PartName="/ppt/media/image4.png" ContentType="image/png"/>
  <Override PartName="/ppt/media/image5.png" ContentType="image/png"/>
  <Override PartName="/ppt/media/image6.wmf" ContentType="image/x-wmf"/>
  <Override PartName="/ppt/media/image7.wmf" ContentType="image/x-wmf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</p:sldMasterIdLst>
  <p:sldIdLst>
    <p:sldId id="256" r:id="rId15"/>
  </p:sldIdLst>
  <p:sldSz cx="6119813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" Target="slides/slide1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92DDAB-0C4F-4650-8E3F-F1D9B62990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F67B09-FE2D-4BED-B011-B2BED6DFDC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E5C5019-2CE6-4A89-B6A2-0099E1D252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03C2030-6CAF-419B-9DD0-82D0EAD305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B9EBCAE-D75A-434A-B0F6-0980CAE4ED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DD3D3E9B-F785-4705-AD1C-983ADF553A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69E48F9-3987-4E08-A2B4-5AD6166C63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6028D52-4B36-4A66-8BB0-B1737875FA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4A20463-551E-43C2-80D7-6FAEE84221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8C018D8-3342-483C-8D8E-522DB5A680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BB08642-CC21-4C9E-AE97-18A1BDC18A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C50F964-40E6-46FD-AB9B-E21A11D1DF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0DF58E-BE59-4ED3-8A3D-A603CE087C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13A4EC8-29D3-4A84-A77A-67F3440046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9F3B1D0-083A-4CB3-A041-E158A59967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14CBADB-4100-4568-A17E-5CAE0063B4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B184419-5D53-41DF-9D3C-457F3CC1D0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8B0BC0E-8050-4228-9AD0-DEA1DE2831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0D31948-CEB6-4695-A6DF-DFA3DD5A1C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23E97A7-9CBE-419D-9998-085C9BB6A7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67D808D6-654D-4B3F-B094-E745613C26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0453724-D459-48CE-95CA-46E8DAD7FC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D145FFD-02A7-47B4-B2FD-88D1E7E65E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9F3A0-4A58-4869-84CB-1A1C633036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59DD149-47B2-4CAC-8868-A94F1F151F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103E4B4-5358-4F35-9507-3A469F2FB4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6411DA6A-3074-4066-8CB5-0A44EA2932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40BCC6E-B544-455F-BBC4-E02596F1E2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93F026B-F2FB-4F44-8347-624CCC1AED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9506B75-CA30-4A01-B841-2381867CA7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F9FC21ED-B13A-4541-900E-62B74C5E5A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C58C6F7D-5E1D-4000-A684-CCDEFC5B88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9C031336-7C61-4493-B92E-5D1340907B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DF884E2-CD3E-4F1C-91FB-DFABC2E3E4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6D9811E-41AB-4932-BA2A-509075EE4BB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013CED9-3A24-4A73-B41E-249FE67188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90F0C606-F80E-4E58-BCE2-CEF93000D8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FAB9C7C-F153-4F77-ACA7-3EB61F52DE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57079D2-8996-4999-A7AB-6058012126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3761D81-3F18-4177-B70E-5640505AAC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2CB893A-A33F-4AAC-A471-9F55B93CF8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B03A1A8-EA4A-4DA9-B447-8B832C32DC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F7F9DBC-5B33-4E56-B9C2-F6369F1ED6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0DCF3990-CF8A-4164-95BF-26BEFCA8A6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6F813C5-B1EB-49F9-9D90-0EF6DD743F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BA09139-E14F-4355-8387-757F487EC8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FD96045-E3AE-4A0D-A5C1-8D8A595BB7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BFEEF992-9380-4866-8B1B-43B124EFB4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7A4EA2D-F587-41A5-8ACC-F72F98CE81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012B8BD-85B9-49BE-B418-0BD9B460A0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50BFC861-52F7-4F71-94A5-57A04D7699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685C0C89-832E-43FA-870D-3E623E0783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F4A53509-8A4B-4087-AA2E-FA72B33F1C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3F2A7C0A-92BA-4D71-98A5-17C7BD012A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195B8004-08EC-481C-A971-256A61B647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50ECC233-3022-4988-B0F0-25A7D5AA1A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C8E09A1-A1D4-4ADC-9771-958B923A96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5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1B97A14A-88C2-46CA-B2DE-BB76C7F471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9C31F6A5-2863-4C64-9FF6-296F292A8D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0D199156-6EC1-40BA-8977-C3A47B1692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E1B5B1C0-088C-4E63-BFCF-B4AC30C5C4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85A9BBBF-C04E-4FBC-8EBC-FCA40CD9ED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FBF65175-8A0E-4B32-8030-ADC8D65B90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9E276983-251E-4249-BDD4-F833734D77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D9F58FB-742D-4E80-822E-42F6769632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809F6F3-24CB-46BE-BABA-9983BC7DD7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0A854EF-490F-44D8-90B0-944820A665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117248A-0A04-4E5C-9681-FFA547595B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7CF9E6-AD9F-4874-AB6B-C2B172BF63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E1979C5-FEE8-4D52-AF1E-695BF86134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4FC09DC-AE94-435A-99AB-4A29A81F1C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E576A37-8ACD-4B75-A56E-E1143C782D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5FC7561-610B-4B5D-ABF2-0C5A8DFE96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F4C98F5-396B-47BB-B18C-48AE524FF1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158D91E-6E39-4CE7-A708-5EDA738259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A77849D-9FBE-45DD-BA81-59CD335BA9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0827EE1-59D1-46CE-B03E-EFA0484772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336F3A7-4C05-4F9F-A1AC-9CD4FF8BC4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DFF8E83-ED10-4F6F-BC63-8DC8F1C00D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A3614-21B7-4431-9050-C044E05C1A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07000BF-0562-47D9-B173-13F0804B96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4D5F965-FD41-4BF2-B9A2-70195C54C3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C2EDC1F-1671-412B-BA03-62B647B0BC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7081FDA-BBEE-44C6-ABCA-4AD7E21A4E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FA254AD-53B5-4A11-9891-5715D41102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E32DF09-74EE-44F5-BBE5-6D4F0B0298E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3ACA832-CFCC-4801-86B5-2A11560443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44CE38F-A03B-47DB-9F3C-76CE36E8DE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8476834-374D-483A-A677-6D79FC8790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524656F-DBB4-43D1-BD55-A73AE73D5E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0A2488-73F6-40B3-A82B-598278A6C9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BCBE0F0-B9BF-4C58-A61E-8BAF85EA5B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17930E1-9473-4737-A86A-32995DE46B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12E4785-5018-4AAF-A98A-DB6207C100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CE38E63-41E6-4F18-A089-C0DD521EA2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0234FBD-E82F-46B8-B7E6-5E7D15F7DC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8EA6A09-0E6D-442F-9ECC-5F02C0E768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5839CF5-4875-4E47-B659-0139A30AC3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A0D88CC-C1EA-4D2E-BBEC-AEC9F09EB5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C1A2DFF-C342-4244-99D9-1E47E26755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F88F7BB-8CA1-4ABC-B652-44421D2450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11FD7-5294-4DC1-AADB-D2F9F96B99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F26C449-281B-4B9F-93FA-00B941ED0A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96B9D22-25EF-4E99-8E63-F00D26C4D3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109AF92-0AC6-4CC9-86D0-95959E03BB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C1CBED3-502A-4251-BAEC-C116BB367D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E30B49F-8C50-4EBF-B3CE-13CB0CDA62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D6D1E27-65F9-4E1A-91E3-B8C12EF021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E832D68-D52E-4F6A-B1FB-6161BE7D0D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7D58BF6-79BE-402A-97B3-EF86BA6D58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37BBBC8-83D9-4B55-ADE8-5D7286CB57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6CDB944-B5D3-4439-BB2C-97DB576063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0ABA4-EB55-4ABF-BAEB-0DAB6BB411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95C0906-3EDA-4EE4-BD5F-0FA6BB97C4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65F1963-CE5C-4C2C-BC57-B0C6204CB4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C9815EB-EB69-4F75-83BB-EEC3094E4C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DD38E201-0539-4932-9FFE-E8730FEA7F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DF93160-E15C-4F5E-983D-A7237FA269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5E3AC60-FE77-479F-8AD3-DC975851BA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1F6100E-44F8-41FA-93C6-52A48646C0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D3C012CE-C55E-4F82-B23C-19DD317E3B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A8503C9-7D6C-4A3A-A8A3-FA284E0FAB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D85FCA51-33AD-4213-8D2A-7ADC4BE15C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91535-BA07-4300-B0E1-9B87CE8640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DAB8B29B-CF5C-47B1-8FC7-582D0CD314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E70D77B-4DCC-4DD5-AC5A-3DA7CDC913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963957A-3881-459E-B2DE-27DA86E99B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546CE77-7357-4FD0-8E37-A83A78E715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6E6CE8C-E059-4956-AB6D-9AB422F46C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EDC58CF-A077-41F1-8094-B121121655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B88D87C-983B-448C-B0CA-89B27BBCA3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195EB47-E0D5-461E-B169-59A34B4311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F3A6B1C9-4CE9-409F-90FE-B7EEAB4841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294EFDF-27C2-4B77-B07A-0DBBA49F8C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51105C-0DB4-475A-A556-7196E99A62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0B8AC09-B69D-4B9B-9908-1D3DB967D1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665A4CFB-B39D-4240-9DBE-E1927EC248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F24ED5C9-B35B-4C75-A446-9C82C8C5BD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D9CAE85-3A10-4828-875B-C93EB41473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3233F81-6758-4685-A29D-D505D5CA2F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2C419E3-37FD-4081-851A-3CAA58F801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7FFA166-9DD6-4CCD-A5FB-1162475131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D1C98ED-2158-4AEB-9038-D6FDA0735A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3017526-C441-4969-AFAE-A615B1B85A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25B7CA7C-ECF5-4DB6-8F4B-CA865D4C48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9A740-94F9-4F20-8602-BEFDDEBEF2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B0C1532-E994-4B5B-B922-784D67BC44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D8002FA-117C-482B-95EE-BE0FFF2B59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2652CDB4-579F-4BF7-8335-80AE9F4644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7D2E0B5-0FEF-465B-A7F1-6277C63648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E93F3721-DD04-4F7D-9BF5-8F37AF1192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393E996-0E2B-4B5B-8339-162015327F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66F8B89-03C0-4C35-8C7D-84E3DC635D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BD9D1E0-7C19-4835-9578-F83D917BF8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CD837E3-6F08-43A1-BB11-73BEA809B1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E28F33D-9D9B-4BE0-8983-4629AFDD69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40788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816120" indent="-4082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224000" indent="-81612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06360" y="8475480"/>
            <a:ext cx="14270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90880" y="8475480"/>
            <a:ext cx="19382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386240" y="8475480"/>
            <a:ext cx="14270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algn="r">
              <a:buClr>
                <a:srgbClr val="898989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algn="r">
              <a:buClr>
                <a:srgbClr val="898989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07BCEF1-377D-4435-AF3C-EF8700DA8EF7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6DA8F0C-C633-4AB4-BB1F-82A8B26860DA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858E283-469B-4FCB-8522-DDCE75F82EE0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9715F25-F112-4D1C-BC62-3A9D649C39B3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PlaceHolder 3"/>
          <p:cNvSpPr>
            <a:spLocks noGrp="1"/>
          </p:cNvSpPr>
          <p:nvPr>
            <p:ph type="dt" idx="37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PlaceHolder 4"/>
          <p:cNvSpPr>
            <a:spLocks noGrp="1"/>
          </p:cNvSpPr>
          <p:nvPr>
            <p:ph type="ftr" idx="38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PlaceHolder 5"/>
          <p:cNvSpPr>
            <a:spLocks noGrp="1"/>
          </p:cNvSpPr>
          <p:nvPr>
            <p:ph type="sldNum" idx="39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95AAD03-3331-4517-917F-E2CBE9BC41BC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8C494A-01E3-42D2-8C2D-B9279A396379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069A24B-7796-4FDB-B69D-1182C94FDF2F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EE48AD8-FD35-4234-8C67-9D2788836DC4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63AA023-9412-4A44-8257-342092DF8ADB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A454AC5-A9B4-4CD1-B28C-F756E324AD5F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AFD48E8-AB5E-4AEA-B54E-C819B42D47CC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EA768F0-A6E1-4C16-9244-328D1AEBD471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algn="r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B0A0C60-40BB-4A15-B8B9-852A4709DE9F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wmf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9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3" name="组 1"/>
          <p:cNvGrpSpPr/>
          <p:nvPr/>
        </p:nvGrpSpPr>
        <p:grpSpPr>
          <a:xfrm>
            <a:off x="1019160" y="5910120"/>
            <a:ext cx="1803960" cy="1865520"/>
            <a:chOff x="1019160" y="5910120"/>
            <a:chExt cx="1803960" cy="1865520"/>
          </a:xfrm>
        </p:grpSpPr>
        <p:pic>
          <p:nvPicPr>
            <p:cNvPr id="534" name="图片 21" descr=""/>
            <p:cNvPicPr/>
            <p:nvPr/>
          </p:nvPicPr>
          <p:blipFill>
            <a:blip r:embed="rId1"/>
            <a:stretch/>
          </p:blipFill>
          <p:spPr>
            <a:xfrm>
              <a:off x="1414440" y="6254280"/>
              <a:ext cx="1391040" cy="1071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5" name="文本框 497"/>
            <p:cNvSpPr/>
            <p:nvPr/>
          </p:nvSpPr>
          <p:spPr>
            <a:xfrm>
              <a:off x="1195200" y="619704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6" name="文本框 498"/>
            <p:cNvSpPr/>
            <p:nvPr/>
          </p:nvSpPr>
          <p:spPr>
            <a:xfrm>
              <a:off x="1195200" y="651168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7" name="文本框 499"/>
            <p:cNvSpPr/>
            <p:nvPr/>
          </p:nvSpPr>
          <p:spPr>
            <a:xfrm>
              <a:off x="1258920" y="68353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8" name="文本框 500"/>
            <p:cNvSpPr/>
            <p:nvPr/>
          </p:nvSpPr>
          <p:spPr>
            <a:xfrm>
              <a:off x="1269720" y="71323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9" name="文本框 506"/>
            <p:cNvSpPr/>
            <p:nvPr/>
          </p:nvSpPr>
          <p:spPr>
            <a:xfrm rot="18856200">
              <a:off x="1230120" y="7362720"/>
              <a:ext cx="56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0" name="文本框 507"/>
            <p:cNvSpPr/>
            <p:nvPr/>
          </p:nvSpPr>
          <p:spPr>
            <a:xfrm rot="18856200">
              <a:off x="1563480" y="7308720"/>
              <a:ext cx="45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1" name="文本框 508"/>
            <p:cNvSpPr/>
            <p:nvPr/>
          </p:nvSpPr>
          <p:spPr>
            <a:xfrm rot="18856200">
              <a:off x="1829880" y="7308720"/>
              <a:ext cx="45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2" name="文本框 509"/>
            <p:cNvSpPr/>
            <p:nvPr/>
          </p:nvSpPr>
          <p:spPr>
            <a:xfrm rot="18856200">
              <a:off x="2086560" y="7308720"/>
              <a:ext cx="45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3" name="文本框 510"/>
            <p:cNvSpPr/>
            <p:nvPr/>
          </p:nvSpPr>
          <p:spPr>
            <a:xfrm rot="18856200">
              <a:off x="2256480" y="7347600"/>
              <a:ext cx="56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0-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44" name="文本框 99" descr=""/>
            <p:cNvPicPr/>
            <p:nvPr/>
          </p:nvPicPr>
          <p:blipFill>
            <a:blip r:embed="rId2"/>
            <a:stretch/>
          </p:blipFill>
          <p:spPr>
            <a:xfrm>
              <a:off x="1019160" y="6298200"/>
              <a:ext cx="336600" cy="983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5" name="文本框 512"/>
            <p:cNvSpPr/>
            <p:nvPr/>
          </p:nvSpPr>
          <p:spPr>
            <a:xfrm>
              <a:off x="2022120" y="5910120"/>
              <a:ext cx="33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6" name="文本框 513"/>
            <p:cNvSpPr/>
            <p:nvPr/>
          </p:nvSpPr>
          <p:spPr>
            <a:xfrm>
              <a:off x="1770120" y="613188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7" name="文本框 514"/>
            <p:cNvSpPr/>
            <p:nvPr/>
          </p:nvSpPr>
          <p:spPr>
            <a:xfrm>
              <a:off x="1830240" y="6017040"/>
              <a:ext cx="62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S p=0.1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48" name="组 515"/>
            <p:cNvGrpSpPr/>
            <p:nvPr/>
          </p:nvGrpSpPr>
          <p:grpSpPr>
            <a:xfrm>
              <a:off x="1643400" y="6277680"/>
              <a:ext cx="477000" cy="47160"/>
              <a:chOff x="1643400" y="6277680"/>
              <a:chExt cx="477000" cy="47160"/>
            </a:xfrm>
          </p:grpSpPr>
          <p:sp>
            <p:nvSpPr>
              <p:cNvPr id="549" name="直线连接符 516"/>
              <p:cNvSpPr/>
              <p:nvPr/>
            </p:nvSpPr>
            <p:spPr>
              <a:xfrm>
                <a:off x="1643400" y="6279120"/>
                <a:ext cx="475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0" name="直线连接符 517"/>
              <p:cNvSpPr/>
              <p:nvPr/>
            </p:nvSpPr>
            <p:spPr>
              <a:xfrm>
                <a:off x="1644480" y="627768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1" name="直线连接符 518"/>
              <p:cNvSpPr/>
              <p:nvPr/>
            </p:nvSpPr>
            <p:spPr>
              <a:xfrm>
                <a:off x="2120400" y="627768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52" name="组 519"/>
            <p:cNvGrpSpPr/>
            <p:nvPr/>
          </p:nvGrpSpPr>
          <p:grpSpPr>
            <a:xfrm>
              <a:off x="1623960" y="6368760"/>
              <a:ext cx="228240" cy="47160"/>
              <a:chOff x="1623960" y="6368760"/>
              <a:chExt cx="228240" cy="47160"/>
            </a:xfrm>
          </p:grpSpPr>
          <p:sp>
            <p:nvSpPr>
              <p:cNvPr id="553" name="直线连接符 520"/>
              <p:cNvSpPr/>
              <p:nvPr/>
            </p:nvSpPr>
            <p:spPr>
              <a:xfrm>
                <a:off x="1627560" y="6370200"/>
                <a:ext cx="222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4" name="直线连接符 521"/>
              <p:cNvSpPr/>
              <p:nvPr/>
            </p:nvSpPr>
            <p:spPr>
              <a:xfrm>
                <a:off x="1623960" y="636876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5" name="直线连接符 522"/>
              <p:cNvSpPr/>
              <p:nvPr/>
            </p:nvSpPr>
            <p:spPr>
              <a:xfrm>
                <a:off x="1852200" y="636876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56" name="组 523"/>
            <p:cNvGrpSpPr/>
            <p:nvPr/>
          </p:nvGrpSpPr>
          <p:grpSpPr>
            <a:xfrm>
              <a:off x="1649880" y="6180120"/>
              <a:ext cx="711360" cy="47160"/>
              <a:chOff x="1649880" y="6180120"/>
              <a:chExt cx="711360" cy="47160"/>
            </a:xfrm>
          </p:grpSpPr>
          <p:sp>
            <p:nvSpPr>
              <p:cNvPr id="557" name="直线连接符 524"/>
              <p:cNvSpPr/>
              <p:nvPr/>
            </p:nvSpPr>
            <p:spPr>
              <a:xfrm>
                <a:off x="1650960" y="6181560"/>
                <a:ext cx="710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8" name="直线连接符 525"/>
              <p:cNvSpPr/>
              <p:nvPr/>
            </p:nvSpPr>
            <p:spPr>
              <a:xfrm>
                <a:off x="1649880" y="618012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9" name="直线连接符 526"/>
              <p:cNvSpPr/>
              <p:nvPr/>
            </p:nvSpPr>
            <p:spPr>
              <a:xfrm>
                <a:off x="2359440" y="618012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60" name="组 527"/>
            <p:cNvGrpSpPr/>
            <p:nvPr/>
          </p:nvGrpSpPr>
          <p:grpSpPr>
            <a:xfrm>
              <a:off x="1656720" y="6063120"/>
              <a:ext cx="977400" cy="47160"/>
              <a:chOff x="1656720" y="6063120"/>
              <a:chExt cx="977400" cy="47160"/>
            </a:xfrm>
          </p:grpSpPr>
          <p:sp>
            <p:nvSpPr>
              <p:cNvPr id="561" name="直线连接符 528"/>
              <p:cNvSpPr/>
              <p:nvPr/>
            </p:nvSpPr>
            <p:spPr>
              <a:xfrm>
                <a:off x="1656720" y="6064560"/>
                <a:ext cx="9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2" name="直线连接符 529"/>
              <p:cNvSpPr/>
              <p:nvPr/>
            </p:nvSpPr>
            <p:spPr>
              <a:xfrm>
                <a:off x="1661400" y="606312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3" name="直线连接符 530"/>
              <p:cNvSpPr/>
              <p:nvPr/>
            </p:nvSpPr>
            <p:spPr>
              <a:xfrm>
                <a:off x="2634120" y="606312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64" name="文本框 531"/>
            <p:cNvSpPr/>
            <p:nvPr/>
          </p:nvSpPr>
          <p:spPr>
            <a:xfrm>
              <a:off x="1645560" y="621936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65" name="组 669"/>
            <p:cNvGrpSpPr/>
            <p:nvPr/>
          </p:nvGrpSpPr>
          <p:grpSpPr>
            <a:xfrm>
              <a:off x="1879560" y="6203520"/>
              <a:ext cx="927000" cy="217080"/>
              <a:chOff x="1879560" y="6203520"/>
              <a:chExt cx="927000" cy="217080"/>
            </a:xfrm>
          </p:grpSpPr>
          <p:sp>
            <p:nvSpPr>
              <p:cNvPr id="566" name="文本框 670"/>
              <p:cNvSpPr/>
              <p:nvPr/>
            </p:nvSpPr>
            <p:spPr>
              <a:xfrm>
                <a:off x="2179440" y="6203520"/>
                <a:ext cx="627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NS p=0.8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567" name="组 671"/>
              <p:cNvGrpSpPr/>
              <p:nvPr/>
            </p:nvGrpSpPr>
            <p:grpSpPr>
              <a:xfrm>
                <a:off x="1879560" y="6373440"/>
                <a:ext cx="753120" cy="47160"/>
                <a:chOff x="1879560" y="6373440"/>
                <a:chExt cx="753120" cy="47160"/>
              </a:xfrm>
            </p:grpSpPr>
            <p:sp>
              <p:nvSpPr>
                <p:cNvPr id="568" name="直线连接符 672"/>
                <p:cNvSpPr/>
                <p:nvPr/>
              </p:nvSpPr>
              <p:spPr>
                <a:xfrm>
                  <a:off x="1879560" y="6374880"/>
                  <a:ext cx="7531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9" name="直线连接符 673"/>
                <p:cNvSpPr/>
                <p:nvPr/>
              </p:nvSpPr>
              <p:spPr>
                <a:xfrm>
                  <a:off x="1886040" y="6373440"/>
                  <a:ext cx="0" cy="471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60" bIns="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0" name="直线连接符 674"/>
                <p:cNvSpPr/>
                <p:nvPr/>
              </p:nvSpPr>
              <p:spPr>
                <a:xfrm>
                  <a:off x="2628360" y="6373440"/>
                  <a:ext cx="0" cy="471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60" bIns="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grpSp>
        <p:nvGrpSpPr>
          <p:cNvPr id="571" name="组 3"/>
          <p:cNvGrpSpPr/>
          <p:nvPr/>
        </p:nvGrpSpPr>
        <p:grpSpPr>
          <a:xfrm>
            <a:off x="3559320" y="5911920"/>
            <a:ext cx="1765440" cy="1866600"/>
            <a:chOff x="3559320" y="5911920"/>
            <a:chExt cx="1765440" cy="1866600"/>
          </a:xfrm>
        </p:grpSpPr>
        <p:pic>
          <p:nvPicPr>
            <p:cNvPr id="572" name="图片 130" descr=""/>
            <p:cNvPicPr/>
            <p:nvPr/>
          </p:nvPicPr>
          <p:blipFill>
            <a:blip r:embed="rId3"/>
            <a:stretch/>
          </p:blipFill>
          <p:spPr>
            <a:xfrm>
              <a:off x="3956040" y="6242400"/>
              <a:ext cx="1343520" cy="1087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3" name="文本框 571"/>
            <p:cNvSpPr/>
            <p:nvPr/>
          </p:nvSpPr>
          <p:spPr>
            <a:xfrm rot="18856200">
              <a:off x="3763800" y="7365600"/>
              <a:ext cx="56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4" name="文本框 572"/>
            <p:cNvSpPr/>
            <p:nvPr/>
          </p:nvSpPr>
          <p:spPr>
            <a:xfrm rot="18856200">
              <a:off x="4088160" y="7311960"/>
              <a:ext cx="45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5" name="文本框 573"/>
            <p:cNvSpPr/>
            <p:nvPr/>
          </p:nvSpPr>
          <p:spPr>
            <a:xfrm rot="18856200">
              <a:off x="4345200" y="7311960"/>
              <a:ext cx="45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6" name="文本框 574"/>
            <p:cNvSpPr/>
            <p:nvPr/>
          </p:nvSpPr>
          <p:spPr>
            <a:xfrm rot="18856200">
              <a:off x="4582080" y="7311960"/>
              <a:ext cx="45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7" name="文本框 575"/>
            <p:cNvSpPr/>
            <p:nvPr/>
          </p:nvSpPr>
          <p:spPr>
            <a:xfrm rot="18856200">
              <a:off x="4740840" y="7350480"/>
              <a:ext cx="56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0-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78" name="文本框 134" descr=""/>
            <p:cNvPicPr/>
            <p:nvPr/>
          </p:nvPicPr>
          <p:blipFill>
            <a:blip r:embed="rId4"/>
            <a:stretch/>
          </p:blipFill>
          <p:spPr>
            <a:xfrm>
              <a:off x="3559320" y="6294960"/>
              <a:ext cx="336600" cy="982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9" name="文本框 597"/>
            <p:cNvSpPr/>
            <p:nvPr/>
          </p:nvSpPr>
          <p:spPr>
            <a:xfrm>
              <a:off x="3794040" y="64368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0" name="文本框 598"/>
            <p:cNvSpPr/>
            <p:nvPr/>
          </p:nvSpPr>
          <p:spPr>
            <a:xfrm>
              <a:off x="3794040" y="66733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1" name="文本框 599"/>
            <p:cNvSpPr/>
            <p:nvPr/>
          </p:nvSpPr>
          <p:spPr>
            <a:xfrm>
              <a:off x="3794040" y="71474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2" name="文本框 600"/>
            <p:cNvSpPr/>
            <p:nvPr/>
          </p:nvSpPr>
          <p:spPr>
            <a:xfrm>
              <a:off x="3794040" y="69109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3" name="文本框 601"/>
            <p:cNvSpPr/>
            <p:nvPr/>
          </p:nvSpPr>
          <p:spPr>
            <a:xfrm>
              <a:off x="3794040" y="6199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4" name="文本框 596"/>
            <p:cNvSpPr/>
            <p:nvPr/>
          </p:nvSpPr>
          <p:spPr>
            <a:xfrm>
              <a:off x="4056480" y="6282720"/>
              <a:ext cx="38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*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5" name="文本框 577"/>
            <p:cNvSpPr/>
            <p:nvPr/>
          </p:nvSpPr>
          <p:spPr>
            <a:xfrm>
              <a:off x="4451040" y="5911920"/>
              <a:ext cx="38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*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6" name="文本框 578"/>
            <p:cNvSpPr/>
            <p:nvPr/>
          </p:nvSpPr>
          <p:spPr>
            <a:xfrm>
              <a:off x="4210560" y="6165720"/>
              <a:ext cx="33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7" name="文本框 579"/>
            <p:cNvSpPr/>
            <p:nvPr/>
          </p:nvSpPr>
          <p:spPr>
            <a:xfrm>
              <a:off x="4310640" y="6042960"/>
              <a:ext cx="62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S p=0.1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88" name="组 580"/>
            <p:cNvGrpSpPr/>
            <p:nvPr/>
          </p:nvGrpSpPr>
          <p:grpSpPr>
            <a:xfrm>
              <a:off x="4144680" y="6321240"/>
              <a:ext cx="459720" cy="47160"/>
              <a:chOff x="4144680" y="6321240"/>
              <a:chExt cx="459720" cy="47160"/>
            </a:xfrm>
          </p:grpSpPr>
          <p:sp>
            <p:nvSpPr>
              <p:cNvPr id="589" name="直线连接符 581"/>
              <p:cNvSpPr/>
              <p:nvPr/>
            </p:nvSpPr>
            <p:spPr>
              <a:xfrm>
                <a:off x="4144680" y="6322680"/>
                <a:ext cx="458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0" name="直线连接符 582"/>
              <p:cNvSpPr/>
              <p:nvPr/>
            </p:nvSpPr>
            <p:spPr>
              <a:xfrm>
                <a:off x="4145760" y="632124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1" name="直线连接符 583"/>
              <p:cNvSpPr/>
              <p:nvPr/>
            </p:nvSpPr>
            <p:spPr>
              <a:xfrm>
                <a:off x="4604400" y="632124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92" name="组 584"/>
            <p:cNvGrpSpPr/>
            <p:nvPr/>
          </p:nvGrpSpPr>
          <p:grpSpPr>
            <a:xfrm>
              <a:off x="4141440" y="6436800"/>
              <a:ext cx="219960" cy="47160"/>
              <a:chOff x="4141440" y="6436800"/>
              <a:chExt cx="219960" cy="47160"/>
            </a:xfrm>
          </p:grpSpPr>
          <p:sp>
            <p:nvSpPr>
              <p:cNvPr id="593" name="直线连接符 585"/>
              <p:cNvSpPr/>
              <p:nvPr/>
            </p:nvSpPr>
            <p:spPr>
              <a:xfrm>
                <a:off x="4145040" y="6438240"/>
                <a:ext cx="21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4" name="直线连接符 586"/>
              <p:cNvSpPr/>
              <p:nvPr/>
            </p:nvSpPr>
            <p:spPr>
              <a:xfrm>
                <a:off x="4141440" y="643680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5" name="直线连接符 587"/>
              <p:cNvSpPr/>
              <p:nvPr/>
            </p:nvSpPr>
            <p:spPr>
              <a:xfrm>
                <a:off x="4361400" y="643680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96" name="组 588"/>
            <p:cNvGrpSpPr/>
            <p:nvPr/>
          </p:nvGrpSpPr>
          <p:grpSpPr>
            <a:xfrm>
              <a:off x="4151160" y="6207120"/>
              <a:ext cx="685440" cy="47160"/>
              <a:chOff x="4151160" y="6207120"/>
              <a:chExt cx="685440" cy="47160"/>
            </a:xfrm>
          </p:grpSpPr>
          <p:sp>
            <p:nvSpPr>
              <p:cNvPr id="597" name="直线连接符 589"/>
              <p:cNvSpPr/>
              <p:nvPr/>
            </p:nvSpPr>
            <p:spPr>
              <a:xfrm>
                <a:off x="4152240" y="6208560"/>
                <a:ext cx="684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8" name="直线连接符 590"/>
              <p:cNvSpPr/>
              <p:nvPr/>
            </p:nvSpPr>
            <p:spPr>
              <a:xfrm>
                <a:off x="4151160" y="620712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9" name="直线连接符 591"/>
              <p:cNvSpPr/>
              <p:nvPr/>
            </p:nvSpPr>
            <p:spPr>
              <a:xfrm>
                <a:off x="4834800" y="620712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00" name="组 592"/>
            <p:cNvGrpSpPr/>
            <p:nvPr/>
          </p:nvGrpSpPr>
          <p:grpSpPr>
            <a:xfrm>
              <a:off x="4158000" y="6077520"/>
              <a:ext cx="941760" cy="47160"/>
              <a:chOff x="4158000" y="6077520"/>
              <a:chExt cx="941760" cy="47160"/>
            </a:xfrm>
          </p:grpSpPr>
          <p:sp>
            <p:nvSpPr>
              <p:cNvPr id="601" name="直线连接符 593"/>
              <p:cNvSpPr/>
              <p:nvPr/>
            </p:nvSpPr>
            <p:spPr>
              <a:xfrm>
                <a:off x="4158000" y="6078960"/>
                <a:ext cx="941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2" name="直线连接符 594"/>
              <p:cNvSpPr/>
              <p:nvPr/>
            </p:nvSpPr>
            <p:spPr>
              <a:xfrm>
                <a:off x="4162680" y="607752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3" name="直线连接符 595"/>
              <p:cNvSpPr/>
              <p:nvPr/>
            </p:nvSpPr>
            <p:spPr>
              <a:xfrm>
                <a:off x="5099760" y="6077520"/>
                <a:ext cx="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04" name="组 681"/>
            <p:cNvGrpSpPr/>
            <p:nvPr/>
          </p:nvGrpSpPr>
          <p:grpSpPr>
            <a:xfrm>
              <a:off x="4387320" y="6267600"/>
              <a:ext cx="937440" cy="217080"/>
              <a:chOff x="4387320" y="6267600"/>
              <a:chExt cx="937440" cy="217080"/>
            </a:xfrm>
          </p:grpSpPr>
          <p:sp>
            <p:nvSpPr>
              <p:cNvPr id="605" name="文本框 682"/>
              <p:cNvSpPr/>
              <p:nvPr/>
            </p:nvSpPr>
            <p:spPr>
              <a:xfrm>
                <a:off x="4697640" y="6267600"/>
                <a:ext cx="627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NS p=0.2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606" name="组 683"/>
              <p:cNvGrpSpPr/>
              <p:nvPr/>
            </p:nvGrpSpPr>
            <p:grpSpPr>
              <a:xfrm>
                <a:off x="4387320" y="6437520"/>
                <a:ext cx="725400" cy="47160"/>
                <a:chOff x="4387320" y="6437520"/>
                <a:chExt cx="725400" cy="47160"/>
              </a:xfrm>
            </p:grpSpPr>
            <p:sp>
              <p:nvSpPr>
                <p:cNvPr id="607" name="直线连接符 684"/>
                <p:cNvSpPr/>
                <p:nvPr/>
              </p:nvSpPr>
              <p:spPr>
                <a:xfrm>
                  <a:off x="4387320" y="6438960"/>
                  <a:ext cx="7254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8" name="直线连接符 685"/>
                <p:cNvSpPr/>
                <p:nvPr/>
              </p:nvSpPr>
              <p:spPr>
                <a:xfrm>
                  <a:off x="4393800" y="6437520"/>
                  <a:ext cx="0" cy="471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60" bIns="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9" name="直线连接符 686"/>
                <p:cNvSpPr/>
                <p:nvPr/>
              </p:nvSpPr>
              <p:spPr>
                <a:xfrm>
                  <a:off x="5108400" y="6437520"/>
                  <a:ext cx="0" cy="471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60" bIns="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sp>
        <p:nvSpPr>
          <p:cNvPr id="610" name="文本框 90"/>
          <p:cNvSpPr/>
          <p:nvPr/>
        </p:nvSpPr>
        <p:spPr>
          <a:xfrm>
            <a:off x="322200" y="5695920"/>
            <a:ext cx="297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1" name="文本框 1"/>
          <p:cNvSpPr/>
          <p:nvPr/>
        </p:nvSpPr>
        <p:spPr>
          <a:xfrm>
            <a:off x="5124600" y="841680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2" name="文本框 370"/>
          <p:cNvSpPr/>
          <p:nvPr/>
        </p:nvSpPr>
        <p:spPr>
          <a:xfrm>
            <a:off x="1880640" y="1960560"/>
            <a:ext cx="42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BC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3" name="文本框 688"/>
          <p:cNvSpPr/>
          <p:nvPr/>
        </p:nvSpPr>
        <p:spPr>
          <a:xfrm>
            <a:off x="323280" y="18543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4" name="文本框 386"/>
          <p:cNvSpPr/>
          <p:nvPr/>
        </p:nvSpPr>
        <p:spPr>
          <a:xfrm rot="18856200">
            <a:off x="2284200" y="3531240"/>
            <a:ext cx="56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0-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5" name="文本框 373" descr=""/>
          <p:cNvPicPr/>
          <p:nvPr/>
        </p:nvPicPr>
        <p:blipFill>
          <a:blip r:embed="rId5"/>
          <a:stretch/>
        </p:blipFill>
        <p:spPr>
          <a:xfrm>
            <a:off x="1038240" y="2467080"/>
            <a:ext cx="336600" cy="982440"/>
          </a:xfrm>
          <a:prstGeom prst="rect">
            <a:avLst/>
          </a:prstGeom>
          <a:ln w="0">
            <a:noFill/>
          </a:ln>
        </p:spPr>
      </p:pic>
      <p:pic>
        <p:nvPicPr>
          <p:cNvPr id="616" name="图片 374" descr=""/>
          <p:cNvPicPr/>
          <p:nvPr/>
        </p:nvPicPr>
        <p:blipFill>
          <a:blip r:embed="rId6"/>
          <a:stretch/>
        </p:blipFill>
        <p:spPr>
          <a:xfrm>
            <a:off x="1468440" y="2409840"/>
            <a:ext cx="1355760" cy="1096920"/>
          </a:xfrm>
          <a:prstGeom prst="rect">
            <a:avLst/>
          </a:prstGeom>
          <a:ln w="0">
            <a:noFill/>
          </a:ln>
        </p:spPr>
      </p:pic>
      <p:sp>
        <p:nvSpPr>
          <p:cNvPr id="617" name="文本框 375"/>
          <p:cNvSpPr/>
          <p:nvPr/>
        </p:nvSpPr>
        <p:spPr>
          <a:xfrm>
            <a:off x="1227600" y="237960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8" name="文本框 376"/>
          <p:cNvSpPr/>
          <p:nvPr/>
        </p:nvSpPr>
        <p:spPr>
          <a:xfrm>
            <a:off x="1227600" y="270036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9" name="文本框 377"/>
          <p:cNvSpPr/>
          <p:nvPr/>
        </p:nvSpPr>
        <p:spPr>
          <a:xfrm>
            <a:off x="1294200" y="30211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文本框 378"/>
          <p:cNvSpPr/>
          <p:nvPr/>
        </p:nvSpPr>
        <p:spPr>
          <a:xfrm>
            <a:off x="1294200" y="33498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1" name="文本框 379"/>
          <p:cNvSpPr/>
          <p:nvPr/>
        </p:nvSpPr>
        <p:spPr>
          <a:xfrm>
            <a:off x="2034720" y="2205000"/>
            <a:ext cx="33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Times New Roman"/>
                <a:ea typeface="宋体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2" name="文本框 380"/>
          <p:cNvSpPr/>
          <p:nvPr/>
        </p:nvSpPr>
        <p:spPr>
          <a:xfrm>
            <a:off x="1694160" y="2459160"/>
            <a:ext cx="62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NS p=0.1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文本框 381"/>
          <p:cNvSpPr/>
          <p:nvPr/>
        </p:nvSpPr>
        <p:spPr>
          <a:xfrm>
            <a:off x="1826280" y="2338560"/>
            <a:ext cx="57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NS =0.0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4" name="文本框 382"/>
          <p:cNvSpPr/>
          <p:nvPr/>
        </p:nvSpPr>
        <p:spPr>
          <a:xfrm rot="18856200">
            <a:off x="1282680" y="3535200"/>
            <a:ext cx="56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5" name="文本框 383"/>
          <p:cNvSpPr/>
          <p:nvPr/>
        </p:nvSpPr>
        <p:spPr>
          <a:xfrm rot="18856200">
            <a:off x="1545840" y="3529080"/>
            <a:ext cx="56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0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6" name="文本框 384"/>
          <p:cNvSpPr/>
          <p:nvPr/>
        </p:nvSpPr>
        <p:spPr>
          <a:xfrm rot="18856200">
            <a:off x="1776240" y="3528360"/>
            <a:ext cx="56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3-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7" name="文本框 385"/>
          <p:cNvSpPr/>
          <p:nvPr/>
        </p:nvSpPr>
        <p:spPr>
          <a:xfrm rot="18856200">
            <a:off x="2039760" y="3530520"/>
            <a:ext cx="56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5-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28" name="组 391"/>
          <p:cNvGrpSpPr/>
          <p:nvPr/>
        </p:nvGrpSpPr>
        <p:grpSpPr>
          <a:xfrm>
            <a:off x="1655640" y="2727360"/>
            <a:ext cx="231840" cy="36360"/>
            <a:chOff x="1655640" y="2727360"/>
            <a:chExt cx="231840" cy="36360"/>
          </a:xfrm>
        </p:grpSpPr>
        <p:sp>
          <p:nvSpPr>
            <p:cNvPr id="629" name="直线连接符 392"/>
            <p:cNvSpPr/>
            <p:nvPr/>
          </p:nvSpPr>
          <p:spPr>
            <a:xfrm>
              <a:off x="1658520" y="2728800"/>
              <a:ext cx="225720" cy="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0" name="直线连接符 393"/>
            <p:cNvSpPr/>
            <p:nvPr/>
          </p:nvSpPr>
          <p:spPr>
            <a:xfrm>
              <a:off x="1655640" y="27273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1" name="直线连接符 394"/>
            <p:cNvSpPr/>
            <p:nvPr/>
          </p:nvSpPr>
          <p:spPr>
            <a:xfrm>
              <a:off x="1887480" y="27273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32" name="组 395"/>
          <p:cNvGrpSpPr/>
          <p:nvPr/>
        </p:nvGrpSpPr>
        <p:grpSpPr>
          <a:xfrm>
            <a:off x="1658880" y="2508120"/>
            <a:ext cx="719280" cy="36720"/>
            <a:chOff x="1658880" y="2508120"/>
            <a:chExt cx="719280" cy="36720"/>
          </a:xfrm>
        </p:grpSpPr>
        <p:sp>
          <p:nvSpPr>
            <p:cNvPr id="633" name="直线连接符 396"/>
            <p:cNvSpPr/>
            <p:nvPr/>
          </p:nvSpPr>
          <p:spPr>
            <a:xfrm>
              <a:off x="1660320" y="2509560"/>
              <a:ext cx="717840" cy="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4" name="直线连接符 397"/>
            <p:cNvSpPr/>
            <p:nvPr/>
          </p:nvSpPr>
          <p:spPr>
            <a:xfrm>
              <a:off x="1658880" y="2508120"/>
              <a:ext cx="0" cy="3672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5" name="直线连接符 398"/>
            <p:cNvSpPr/>
            <p:nvPr/>
          </p:nvSpPr>
          <p:spPr>
            <a:xfrm>
              <a:off x="2376720" y="2508120"/>
              <a:ext cx="0" cy="3672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36" name="组 399"/>
          <p:cNvGrpSpPr/>
          <p:nvPr/>
        </p:nvGrpSpPr>
        <p:grpSpPr>
          <a:xfrm>
            <a:off x="1665360" y="2365200"/>
            <a:ext cx="988920" cy="36720"/>
            <a:chOff x="1665360" y="2365200"/>
            <a:chExt cx="988920" cy="36720"/>
          </a:xfrm>
        </p:grpSpPr>
        <p:sp>
          <p:nvSpPr>
            <p:cNvPr id="637" name="直线连接符 400"/>
            <p:cNvSpPr/>
            <p:nvPr/>
          </p:nvSpPr>
          <p:spPr>
            <a:xfrm>
              <a:off x="1665360" y="2366640"/>
              <a:ext cx="987480" cy="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8" name="直线连接符 401"/>
            <p:cNvSpPr/>
            <p:nvPr/>
          </p:nvSpPr>
          <p:spPr>
            <a:xfrm>
              <a:off x="1670040" y="2365200"/>
              <a:ext cx="0" cy="3672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9" name="直线连接符 402"/>
            <p:cNvSpPr/>
            <p:nvPr/>
          </p:nvSpPr>
          <p:spPr>
            <a:xfrm>
              <a:off x="2654280" y="2365200"/>
              <a:ext cx="0" cy="3672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40" name="文本框 403"/>
          <p:cNvSpPr/>
          <p:nvPr/>
        </p:nvSpPr>
        <p:spPr>
          <a:xfrm>
            <a:off x="1586880" y="2570040"/>
            <a:ext cx="33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Times New Roman"/>
                <a:ea typeface="宋体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1" name="组 617"/>
          <p:cNvGrpSpPr/>
          <p:nvPr/>
        </p:nvGrpSpPr>
        <p:grpSpPr>
          <a:xfrm>
            <a:off x="1649520" y="2625840"/>
            <a:ext cx="465120" cy="39600"/>
            <a:chOff x="1649520" y="2625840"/>
            <a:chExt cx="465120" cy="39600"/>
          </a:xfrm>
        </p:grpSpPr>
        <p:sp>
          <p:nvSpPr>
            <p:cNvPr id="642" name="直线连接符 618"/>
            <p:cNvSpPr/>
            <p:nvPr/>
          </p:nvSpPr>
          <p:spPr>
            <a:xfrm>
              <a:off x="1649520" y="2627280"/>
              <a:ext cx="465120" cy="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3" name="直线连接符 619"/>
            <p:cNvSpPr/>
            <p:nvPr/>
          </p:nvSpPr>
          <p:spPr>
            <a:xfrm>
              <a:off x="1653480" y="262584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4" name="直线连接符 620"/>
            <p:cNvSpPr/>
            <p:nvPr/>
          </p:nvSpPr>
          <p:spPr>
            <a:xfrm>
              <a:off x="2108520" y="262584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645" name="图片 404" descr=""/>
          <p:cNvPicPr/>
          <p:nvPr/>
        </p:nvPicPr>
        <p:blipFill>
          <a:blip r:embed="rId7"/>
          <a:stretch/>
        </p:blipFill>
        <p:spPr>
          <a:xfrm>
            <a:off x="3914640" y="2401920"/>
            <a:ext cx="1384560" cy="1095480"/>
          </a:xfrm>
          <a:prstGeom prst="rect">
            <a:avLst/>
          </a:prstGeom>
          <a:ln w="0">
            <a:noFill/>
          </a:ln>
        </p:spPr>
      </p:pic>
      <p:pic>
        <p:nvPicPr>
          <p:cNvPr id="646" name="文本框 405" descr=""/>
          <p:cNvPicPr/>
          <p:nvPr/>
        </p:nvPicPr>
        <p:blipFill>
          <a:blip r:embed="rId8"/>
          <a:stretch/>
        </p:blipFill>
        <p:spPr>
          <a:xfrm>
            <a:off x="3549600" y="2459160"/>
            <a:ext cx="336600" cy="981000"/>
          </a:xfrm>
          <a:prstGeom prst="rect">
            <a:avLst/>
          </a:prstGeom>
          <a:ln w="0">
            <a:noFill/>
          </a:ln>
        </p:spPr>
      </p:pic>
      <p:sp>
        <p:nvSpPr>
          <p:cNvPr id="647" name="文本框 406"/>
          <p:cNvSpPr/>
          <p:nvPr/>
        </p:nvSpPr>
        <p:spPr>
          <a:xfrm>
            <a:off x="4503240" y="2151000"/>
            <a:ext cx="33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Times New Roman"/>
                <a:ea typeface="宋体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8" name="文本框 407"/>
          <p:cNvSpPr/>
          <p:nvPr/>
        </p:nvSpPr>
        <p:spPr>
          <a:xfrm>
            <a:off x="4160880" y="2432160"/>
            <a:ext cx="62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NS p=0.0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9" name="文本框 408"/>
          <p:cNvSpPr/>
          <p:nvPr/>
        </p:nvSpPr>
        <p:spPr>
          <a:xfrm>
            <a:off x="4294440" y="2290680"/>
            <a:ext cx="62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NS p=0.1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0" name="文本框 409"/>
          <p:cNvSpPr/>
          <p:nvPr/>
        </p:nvSpPr>
        <p:spPr>
          <a:xfrm rot="18856200">
            <a:off x="3736800" y="3522240"/>
            <a:ext cx="56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1" name="文本框 410"/>
          <p:cNvSpPr/>
          <p:nvPr/>
        </p:nvSpPr>
        <p:spPr>
          <a:xfrm rot="18856200">
            <a:off x="4000320" y="3515760"/>
            <a:ext cx="56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0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2" name="文本框 411"/>
          <p:cNvSpPr/>
          <p:nvPr/>
        </p:nvSpPr>
        <p:spPr>
          <a:xfrm rot="18856200">
            <a:off x="4231800" y="3516480"/>
            <a:ext cx="56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3-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3" name="文本框 412"/>
          <p:cNvSpPr/>
          <p:nvPr/>
        </p:nvSpPr>
        <p:spPr>
          <a:xfrm rot="18856200">
            <a:off x="4495320" y="3517920"/>
            <a:ext cx="56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5-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4" name="文本框 413"/>
          <p:cNvSpPr/>
          <p:nvPr/>
        </p:nvSpPr>
        <p:spPr>
          <a:xfrm rot="18856200">
            <a:off x="4740120" y="3517920"/>
            <a:ext cx="56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0-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55" name="组 418"/>
          <p:cNvGrpSpPr/>
          <p:nvPr/>
        </p:nvGrpSpPr>
        <p:grpSpPr>
          <a:xfrm>
            <a:off x="4124160" y="2717640"/>
            <a:ext cx="231840" cy="34920"/>
            <a:chOff x="4124160" y="2717640"/>
            <a:chExt cx="231840" cy="34920"/>
          </a:xfrm>
        </p:grpSpPr>
        <p:sp>
          <p:nvSpPr>
            <p:cNvPr id="656" name="直线连接符 419"/>
            <p:cNvSpPr/>
            <p:nvPr/>
          </p:nvSpPr>
          <p:spPr>
            <a:xfrm>
              <a:off x="4127040" y="2719080"/>
              <a:ext cx="225720" cy="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7" name="直线连接符 420"/>
            <p:cNvSpPr/>
            <p:nvPr/>
          </p:nvSpPr>
          <p:spPr>
            <a:xfrm>
              <a:off x="4124160" y="271764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8" name="直线连接符 421"/>
            <p:cNvSpPr/>
            <p:nvPr/>
          </p:nvSpPr>
          <p:spPr>
            <a:xfrm>
              <a:off x="4356000" y="271764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59" name="组 422"/>
          <p:cNvGrpSpPr/>
          <p:nvPr/>
        </p:nvGrpSpPr>
        <p:grpSpPr>
          <a:xfrm>
            <a:off x="4127400" y="2460600"/>
            <a:ext cx="720720" cy="34920"/>
            <a:chOff x="4127400" y="2460600"/>
            <a:chExt cx="720720" cy="34920"/>
          </a:xfrm>
        </p:grpSpPr>
        <p:sp>
          <p:nvSpPr>
            <p:cNvPr id="660" name="直线连接符 423"/>
            <p:cNvSpPr/>
            <p:nvPr/>
          </p:nvSpPr>
          <p:spPr>
            <a:xfrm>
              <a:off x="4128840" y="2462040"/>
              <a:ext cx="719280" cy="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1" name="直线连接符 424"/>
            <p:cNvSpPr/>
            <p:nvPr/>
          </p:nvSpPr>
          <p:spPr>
            <a:xfrm>
              <a:off x="4127400" y="246060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2" name="直线连接符 425"/>
            <p:cNvSpPr/>
            <p:nvPr/>
          </p:nvSpPr>
          <p:spPr>
            <a:xfrm>
              <a:off x="4846680" y="246060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63" name="组 426"/>
          <p:cNvGrpSpPr/>
          <p:nvPr/>
        </p:nvGrpSpPr>
        <p:grpSpPr>
          <a:xfrm>
            <a:off x="4133880" y="2311560"/>
            <a:ext cx="990720" cy="36360"/>
            <a:chOff x="4133880" y="2311560"/>
            <a:chExt cx="990720" cy="36360"/>
          </a:xfrm>
        </p:grpSpPr>
        <p:sp>
          <p:nvSpPr>
            <p:cNvPr id="664" name="直线连接符 427"/>
            <p:cNvSpPr/>
            <p:nvPr/>
          </p:nvSpPr>
          <p:spPr>
            <a:xfrm>
              <a:off x="4133880" y="2313000"/>
              <a:ext cx="989280" cy="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5" name="直线连接符 428"/>
            <p:cNvSpPr/>
            <p:nvPr/>
          </p:nvSpPr>
          <p:spPr>
            <a:xfrm>
              <a:off x="4138560" y="23115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6" name="直线连接符 429"/>
            <p:cNvSpPr/>
            <p:nvPr/>
          </p:nvSpPr>
          <p:spPr>
            <a:xfrm>
              <a:off x="5124600" y="23115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67" name="文本框 430"/>
          <p:cNvSpPr/>
          <p:nvPr/>
        </p:nvSpPr>
        <p:spPr>
          <a:xfrm>
            <a:off x="4068360" y="2573280"/>
            <a:ext cx="33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Times New Roman"/>
                <a:ea typeface="宋体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8" name="文本框 431"/>
          <p:cNvSpPr/>
          <p:nvPr/>
        </p:nvSpPr>
        <p:spPr>
          <a:xfrm>
            <a:off x="3756600" y="25812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9" name="文本框 432"/>
          <p:cNvSpPr/>
          <p:nvPr/>
        </p:nvSpPr>
        <p:spPr>
          <a:xfrm>
            <a:off x="3751200" y="28177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0" name="文本框 433"/>
          <p:cNvSpPr/>
          <p:nvPr/>
        </p:nvSpPr>
        <p:spPr>
          <a:xfrm>
            <a:off x="3756600" y="332424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1" name="文本框 434"/>
          <p:cNvSpPr/>
          <p:nvPr/>
        </p:nvSpPr>
        <p:spPr>
          <a:xfrm>
            <a:off x="3751200" y="305604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2" name="文本框 435"/>
          <p:cNvSpPr/>
          <p:nvPr/>
        </p:nvSpPr>
        <p:spPr>
          <a:xfrm>
            <a:off x="3756600" y="2344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73" name="组 617"/>
          <p:cNvGrpSpPr/>
          <p:nvPr/>
        </p:nvGrpSpPr>
        <p:grpSpPr>
          <a:xfrm>
            <a:off x="4121280" y="2587680"/>
            <a:ext cx="465120" cy="39600"/>
            <a:chOff x="4121280" y="2587680"/>
            <a:chExt cx="465120" cy="39600"/>
          </a:xfrm>
        </p:grpSpPr>
        <p:sp>
          <p:nvSpPr>
            <p:cNvPr id="674" name="直线连接符 618"/>
            <p:cNvSpPr/>
            <p:nvPr/>
          </p:nvSpPr>
          <p:spPr>
            <a:xfrm>
              <a:off x="4121280" y="2589120"/>
              <a:ext cx="465120" cy="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5" name="直线连接符 619"/>
            <p:cNvSpPr/>
            <p:nvPr/>
          </p:nvSpPr>
          <p:spPr>
            <a:xfrm>
              <a:off x="4125240" y="25876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6" name="直线连接符 620"/>
            <p:cNvSpPr/>
            <p:nvPr/>
          </p:nvSpPr>
          <p:spPr>
            <a:xfrm>
              <a:off x="4580280" y="25876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77" name="文本框 370"/>
          <p:cNvSpPr/>
          <p:nvPr/>
        </p:nvSpPr>
        <p:spPr>
          <a:xfrm>
            <a:off x="4344480" y="1960560"/>
            <a:ext cx="42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BC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8" name="文本框 370"/>
          <p:cNvSpPr/>
          <p:nvPr/>
        </p:nvSpPr>
        <p:spPr>
          <a:xfrm>
            <a:off x="1885320" y="5689440"/>
            <a:ext cx="42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BC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9" name="文本框 370"/>
          <p:cNvSpPr/>
          <p:nvPr/>
        </p:nvSpPr>
        <p:spPr>
          <a:xfrm>
            <a:off x="4409640" y="5689440"/>
            <a:ext cx="42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BC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0" name="直线连接符 180"/>
          <p:cNvSpPr/>
          <p:nvPr/>
        </p:nvSpPr>
        <p:spPr>
          <a:xfrm>
            <a:off x="1177920" y="938160"/>
            <a:ext cx="0" cy="13968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1" name="直线连接符 181"/>
          <p:cNvSpPr/>
          <p:nvPr/>
        </p:nvSpPr>
        <p:spPr>
          <a:xfrm>
            <a:off x="1500120" y="938160"/>
            <a:ext cx="0" cy="13968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2" name="直线连接符 182"/>
          <p:cNvSpPr/>
          <p:nvPr/>
        </p:nvSpPr>
        <p:spPr>
          <a:xfrm>
            <a:off x="1824120" y="938160"/>
            <a:ext cx="0" cy="13968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3" name="直线连接符 183"/>
          <p:cNvSpPr/>
          <p:nvPr/>
        </p:nvSpPr>
        <p:spPr>
          <a:xfrm>
            <a:off x="2085840" y="938160"/>
            <a:ext cx="0" cy="13968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4" name="直线连接符 184"/>
          <p:cNvSpPr/>
          <p:nvPr/>
        </p:nvSpPr>
        <p:spPr>
          <a:xfrm>
            <a:off x="2946240" y="938160"/>
            <a:ext cx="0" cy="13968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5" name="直线连接符 185"/>
          <p:cNvSpPr/>
          <p:nvPr/>
        </p:nvSpPr>
        <p:spPr>
          <a:xfrm>
            <a:off x="3790800" y="938160"/>
            <a:ext cx="0" cy="13968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6" name="直线连接符 186"/>
          <p:cNvSpPr/>
          <p:nvPr/>
        </p:nvSpPr>
        <p:spPr>
          <a:xfrm>
            <a:off x="4859280" y="938160"/>
            <a:ext cx="0" cy="13968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7" name="文本框 188"/>
          <p:cNvSpPr/>
          <p:nvPr/>
        </p:nvSpPr>
        <p:spPr>
          <a:xfrm>
            <a:off x="635760" y="700200"/>
            <a:ext cx="39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8" name="文本框 189"/>
          <p:cNvSpPr/>
          <p:nvPr/>
        </p:nvSpPr>
        <p:spPr>
          <a:xfrm>
            <a:off x="1065600" y="7002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9" name="文本框 190"/>
          <p:cNvSpPr/>
          <p:nvPr/>
        </p:nvSpPr>
        <p:spPr>
          <a:xfrm>
            <a:off x="1383120" y="7002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0" name="文本框 191"/>
          <p:cNvSpPr/>
          <p:nvPr/>
        </p:nvSpPr>
        <p:spPr>
          <a:xfrm>
            <a:off x="1689480" y="7002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1" name="文本框 192"/>
          <p:cNvSpPr/>
          <p:nvPr/>
        </p:nvSpPr>
        <p:spPr>
          <a:xfrm>
            <a:off x="1972080" y="7002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2" name="文本框 193"/>
          <p:cNvSpPr/>
          <p:nvPr/>
        </p:nvSpPr>
        <p:spPr>
          <a:xfrm>
            <a:off x="2823120" y="7002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3" name="文本框 194"/>
          <p:cNvSpPr/>
          <p:nvPr/>
        </p:nvSpPr>
        <p:spPr>
          <a:xfrm>
            <a:off x="3667680" y="7002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4" name="文本框 195"/>
          <p:cNvSpPr/>
          <p:nvPr/>
        </p:nvSpPr>
        <p:spPr>
          <a:xfrm>
            <a:off x="4708800" y="70020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95" name="直线箭头连接符 23"/>
          <p:cNvCxnSpPr/>
          <p:nvPr/>
        </p:nvCxnSpPr>
        <p:spPr>
          <a:xfrm flipV="1">
            <a:off x="818640" y="995040"/>
            <a:ext cx="4480920" cy="864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sp>
        <p:nvSpPr>
          <p:cNvPr id="696" name="文本框 219"/>
          <p:cNvSpPr/>
          <p:nvPr/>
        </p:nvSpPr>
        <p:spPr>
          <a:xfrm>
            <a:off x="3836880" y="1285920"/>
            <a:ext cx="14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flow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ytometry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nalysi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97" name="直线箭头连接符 226"/>
          <p:cNvCxnSpPr/>
          <p:nvPr/>
        </p:nvCxnSpPr>
        <p:spPr>
          <a:xfrm>
            <a:off x="3790440" y="995400"/>
            <a:ext cx="1080" cy="24984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sp>
        <p:nvSpPr>
          <p:cNvPr id="698" name="文本框 227"/>
          <p:cNvSpPr/>
          <p:nvPr/>
        </p:nvSpPr>
        <p:spPr>
          <a:xfrm>
            <a:off x="3658680" y="1168560"/>
            <a:ext cx="52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D4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99" name="直线箭头连接符 228"/>
          <p:cNvCxnSpPr/>
          <p:nvPr/>
        </p:nvCxnSpPr>
        <p:spPr>
          <a:xfrm>
            <a:off x="4858920" y="995400"/>
            <a:ext cx="1080" cy="24984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sp>
        <p:nvSpPr>
          <p:cNvPr id="700" name="文本框 229"/>
          <p:cNvSpPr/>
          <p:nvPr/>
        </p:nvSpPr>
        <p:spPr>
          <a:xfrm>
            <a:off x="4695120" y="1168560"/>
            <a:ext cx="52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D45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01" name="组 2"/>
          <p:cNvGrpSpPr/>
          <p:nvPr/>
        </p:nvGrpSpPr>
        <p:grpSpPr>
          <a:xfrm>
            <a:off x="1158840" y="1020600"/>
            <a:ext cx="925560" cy="246240"/>
            <a:chOff x="1158840" y="1020600"/>
            <a:chExt cx="925560" cy="246240"/>
          </a:xfrm>
        </p:grpSpPr>
        <p:sp>
          <p:nvSpPr>
            <p:cNvPr id="702" name="矩形 1"/>
            <p:cNvSpPr/>
            <p:nvPr/>
          </p:nvSpPr>
          <p:spPr>
            <a:xfrm>
              <a:off x="1158840" y="1080720"/>
              <a:ext cx="925560" cy="144720"/>
            </a:xfrm>
            <a:prstGeom prst="rect">
              <a:avLst/>
            </a:prstGeom>
            <a:solidFill>
              <a:srgbClr val="fea695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3" name="文本框 236"/>
            <p:cNvSpPr/>
            <p:nvPr/>
          </p:nvSpPr>
          <p:spPr>
            <a:xfrm>
              <a:off x="1212840" y="1020600"/>
              <a:ext cx="807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04" name="组 440"/>
          <p:cNvGrpSpPr/>
          <p:nvPr/>
        </p:nvGrpSpPr>
        <p:grpSpPr>
          <a:xfrm>
            <a:off x="1168560" y="1465200"/>
            <a:ext cx="2627280" cy="246240"/>
            <a:chOff x="1168560" y="1465200"/>
            <a:chExt cx="2627280" cy="246240"/>
          </a:xfrm>
        </p:grpSpPr>
        <p:sp>
          <p:nvSpPr>
            <p:cNvPr id="705" name="矩形 441"/>
            <p:cNvSpPr/>
            <p:nvPr/>
          </p:nvSpPr>
          <p:spPr>
            <a:xfrm>
              <a:off x="1168560" y="1520640"/>
              <a:ext cx="2627280" cy="141840"/>
            </a:xfrm>
            <a:prstGeom prst="rect">
              <a:avLst/>
            </a:prstGeom>
            <a:solidFill>
              <a:srgbClr val="fea695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6" name="文本框 236"/>
            <p:cNvSpPr/>
            <p:nvPr/>
          </p:nvSpPr>
          <p:spPr>
            <a:xfrm>
              <a:off x="1855080" y="1465200"/>
              <a:ext cx="122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07" name="组 443"/>
          <p:cNvGrpSpPr/>
          <p:nvPr/>
        </p:nvGrpSpPr>
        <p:grpSpPr>
          <a:xfrm>
            <a:off x="2085840" y="1168560"/>
            <a:ext cx="854280" cy="246240"/>
            <a:chOff x="2085840" y="1168560"/>
            <a:chExt cx="854280" cy="246240"/>
          </a:xfrm>
        </p:grpSpPr>
        <p:sp>
          <p:nvSpPr>
            <p:cNvPr id="708" name="矩形 444"/>
            <p:cNvSpPr/>
            <p:nvPr/>
          </p:nvSpPr>
          <p:spPr>
            <a:xfrm>
              <a:off x="2085840" y="1228320"/>
              <a:ext cx="854280" cy="144720"/>
            </a:xfrm>
            <a:prstGeom prst="rect">
              <a:avLst/>
            </a:prstGeom>
            <a:solidFill>
              <a:srgbClr val="fea695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9" name="文本框 236"/>
            <p:cNvSpPr/>
            <p:nvPr/>
          </p:nvSpPr>
          <p:spPr>
            <a:xfrm>
              <a:off x="2104200" y="1168560"/>
              <a:ext cx="807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10" name="组 446"/>
          <p:cNvGrpSpPr/>
          <p:nvPr/>
        </p:nvGrpSpPr>
        <p:grpSpPr>
          <a:xfrm>
            <a:off x="2941560" y="1314360"/>
            <a:ext cx="854280" cy="246240"/>
            <a:chOff x="2941560" y="1314360"/>
            <a:chExt cx="854280" cy="246240"/>
          </a:xfrm>
        </p:grpSpPr>
        <p:sp>
          <p:nvSpPr>
            <p:cNvPr id="711" name="矩形 447"/>
            <p:cNvSpPr/>
            <p:nvPr/>
          </p:nvSpPr>
          <p:spPr>
            <a:xfrm>
              <a:off x="2941560" y="1374120"/>
              <a:ext cx="854280" cy="144720"/>
            </a:xfrm>
            <a:prstGeom prst="rect">
              <a:avLst/>
            </a:prstGeom>
            <a:solidFill>
              <a:srgbClr val="fea695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2" name="文本框 236"/>
            <p:cNvSpPr/>
            <p:nvPr/>
          </p:nvSpPr>
          <p:spPr>
            <a:xfrm>
              <a:off x="2959920" y="1314360"/>
              <a:ext cx="807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13" name="组 6"/>
          <p:cNvGrpSpPr/>
          <p:nvPr/>
        </p:nvGrpSpPr>
        <p:grpSpPr>
          <a:xfrm>
            <a:off x="989640" y="4309920"/>
            <a:ext cx="4608360" cy="1001880"/>
            <a:chOff x="989640" y="4309920"/>
            <a:chExt cx="4608360" cy="1001880"/>
          </a:xfrm>
        </p:grpSpPr>
        <p:sp>
          <p:nvSpPr>
            <p:cNvPr id="714" name="直线连接符 180"/>
            <p:cNvSpPr/>
            <p:nvPr/>
          </p:nvSpPr>
          <p:spPr>
            <a:xfrm>
              <a:off x="1479960" y="4536000"/>
              <a:ext cx="0" cy="14112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5" name="直线连接符 181"/>
            <p:cNvSpPr/>
            <p:nvPr/>
          </p:nvSpPr>
          <p:spPr>
            <a:xfrm>
              <a:off x="2156040" y="4536000"/>
              <a:ext cx="0" cy="14112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6" name="直线连接符 182"/>
            <p:cNvSpPr/>
            <p:nvPr/>
          </p:nvSpPr>
          <p:spPr>
            <a:xfrm>
              <a:off x="2833920" y="4536000"/>
              <a:ext cx="0" cy="14112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7" name="直线连接符 183"/>
            <p:cNvSpPr/>
            <p:nvPr/>
          </p:nvSpPr>
          <p:spPr>
            <a:xfrm>
              <a:off x="3988800" y="4529160"/>
              <a:ext cx="0" cy="14112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8" name="直线连接符 184"/>
            <p:cNvSpPr/>
            <p:nvPr/>
          </p:nvSpPr>
          <p:spPr>
            <a:xfrm>
              <a:off x="3510720" y="4536000"/>
              <a:ext cx="0" cy="14112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9" name="直线连接符 185"/>
            <p:cNvSpPr/>
            <p:nvPr/>
          </p:nvSpPr>
          <p:spPr>
            <a:xfrm>
              <a:off x="4476600" y="4536000"/>
              <a:ext cx="0" cy="14112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0" name="直线连接符 186"/>
            <p:cNvSpPr/>
            <p:nvPr/>
          </p:nvSpPr>
          <p:spPr>
            <a:xfrm>
              <a:off x="5025960" y="4536000"/>
              <a:ext cx="0" cy="14112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1" name="文本框 188"/>
            <p:cNvSpPr/>
            <p:nvPr/>
          </p:nvSpPr>
          <p:spPr>
            <a:xfrm>
              <a:off x="989640" y="4309920"/>
              <a:ext cx="39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22" name="组 233"/>
            <p:cNvGrpSpPr/>
            <p:nvPr/>
          </p:nvGrpSpPr>
          <p:grpSpPr>
            <a:xfrm>
              <a:off x="1367640" y="4309920"/>
              <a:ext cx="3815280" cy="246240"/>
              <a:chOff x="1367640" y="4309920"/>
              <a:chExt cx="3815280" cy="246240"/>
            </a:xfrm>
          </p:grpSpPr>
          <p:sp>
            <p:nvSpPr>
              <p:cNvPr id="723" name="文本框 189"/>
              <p:cNvSpPr/>
              <p:nvPr/>
            </p:nvSpPr>
            <p:spPr>
              <a:xfrm>
                <a:off x="1367640" y="4309920"/>
                <a:ext cx="24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4" name="文本框 190"/>
              <p:cNvSpPr/>
              <p:nvPr/>
            </p:nvSpPr>
            <p:spPr>
              <a:xfrm>
                <a:off x="2034000" y="4309920"/>
                <a:ext cx="24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5" name="文本框 191"/>
              <p:cNvSpPr/>
              <p:nvPr/>
            </p:nvSpPr>
            <p:spPr>
              <a:xfrm>
                <a:off x="2707560" y="4309920"/>
                <a:ext cx="24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6" name="文本框 192"/>
              <p:cNvSpPr/>
              <p:nvPr/>
            </p:nvSpPr>
            <p:spPr>
              <a:xfrm>
                <a:off x="3382920" y="4309920"/>
                <a:ext cx="24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7" name="文本框 193"/>
              <p:cNvSpPr/>
              <p:nvPr/>
            </p:nvSpPr>
            <p:spPr>
              <a:xfrm>
                <a:off x="3877200" y="4309920"/>
                <a:ext cx="24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8" name="文本框 194"/>
              <p:cNvSpPr/>
              <p:nvPr/>
            </p:nvSpPr>
            <p:spPr>
              <a:xfrm>
                <a:off x="4356000" y="4309920"/>
                <a:ext cx="24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7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9" name="文本框 195"/>
              <p:cNvSpPr/>
              <p:nvPr/>
            </p:nvSpPr>
            <p:spPr>
              <a:xfrm>
                <a:off x="4874040" y="4309920"/>
                <a:ext cx="30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cxnSp>
          <p:nvCxnSpPr>
            <p:cNvPr id="730" name="直线箭头连接符 23"/>
            <p:cNvCxnSpPr/>
            <p:nvPr/>
          </p:nvCxnSpPr>
          <p:spPr>
            <a:xfrm flipV="1">
              <a:off x="1063800" y="4592520"/>
              <a:ext cx="4534560" cy="9360"/>
            </a:xfrm>
            <a:prstGeom prst="straightConnector1">
              <a:avLst/>
            </a:prstGeom>
            <a:ln w="19080">
              <a:solidFill>
                <a:srgbClr val="000000"/>
              </a:solidFill>
              <a:round/>
              <a:tailEnd len="med" type="arrow" w="med"/>
            </a:ln>
          </p:spPr>
        </p:cxnSp>
        <p:sp>
          <p:nvSpPr>
            <p:cNvPr id="731" name="文本框 219"/>
            <p:cNvSpPr/>
            <p:nvPr/>
          </p:nvSpPr>
          <p:spPr>
            <a:xfrm>
              <a:off x="4132800" y="4889160"/>
              <a:ext cx="140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low</a:t>
              </a: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ytometry</a:t>
              </a: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nalysi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32" name="直线箭头连接符 226"/>
            <p:cNvCxnSpPr/>
            <p:nvPr/>
          </p:nvCxnSpPr>
          <p:spPr>
            <a:xfrm>
              <a:off x="4476240" y="4602960"/>
              <a:ext cx="1080" cy="252720"/>
            </a:xfrm>
            <a:prstGeom prst="straightConnector1">
              <a:avLst/>
            </a:prstGeom>
            <a:ln w="19080">
              <a:solidFill>
                <a:srgbClr val="000000"/>
              </a:solidFill>
              <a:round/>
              <a:tailEnd len="med" type="arrow" w="med"/>
            </a:ln>
          </p:spPr>
        </p:cxnSp>
        <p:sp>
          <p:nvSpPr>
            <p:cNvPr id="733" name="文本框 227"/>
            <p:cNvSpPr/>
            <p:nvPr/>
          </p:nvSpPr>
          <p:spPr>
            <a:xfrm>
              <a:off x="4224960" y="4770360"/>
              <a:ext cx="524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D43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Times New Roman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34" name="直线箭头连接符 228"/>
            <p:cNvCxnSpPr/>
            <p:nvPr/>
          </p:nvCxnSpPr>
          <p:spPr>
            <a:xfrm>
              <a:off x="5025600" y="4602960"/>
              <a:ext cx="1080" cy="252720"/>
            </a:xfrm>
            <a:prstGeom prst="straightConnector1">
              <a:avLst/>
            </a:prstGeom>
            <a:ln w="19080">
              <a:solidFill>
                <a:srgbClr val="000000"/>
              </a:solidFill>
              <a:round/>
              <a:tailEnd len="med" type="arrow" w="med"/>
            </a:ln>
          </p:spPr>
        </p:cxnSp>
        <p:sp>
          <p:nvSpPr>
            <p:cNvPr id="735" name="文本框 229"/>
            <p:cNvSpPr/>
            <p:nvPr/>
          </p:nvSpPr>
          <p:spPr>
            <a:xfrm>
              <a:off x="4781520" y="4770360"/>
              <a:ext cx="524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D45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Times New Roman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36" name="组 470"/>
            <p:cNvGrpSpPr/>
            <p:nvPr/>
          </p:nvGrpSpPr>
          <p:grpSpPr>
            <a:xfrm>
              <a:off x="1406160" y="4619160"/>
              <a:ext cx="807120" cy="246240"/>
              <a:chOff x="1406160" y="4619160"/>
              <a:chExt cx="807120" cy="246240"/>
            </a:xfrm>
          </p:grpSpPr>
          <p:sp>
            <p:nvSpPr>
              <p:cNvPr id="737" name="矩形 480"/>
              <p:cNvSpPr/>
              <p:nvPr/>
            </p:nvSpPr>
            <p:spPr>
              <a:xfrm>
                <a:off x="1471680" y="4680000"/>
                <a:ext cx="684000" cy="146520"/>
              </a:xfrm>
              <a:prstGeom prst="rect">
                <a:avLst/>
              </a:prstGeom>
              <a:solidFill>
                <a:srgbClr val="fea695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8" name="文本框 236"/>
              <p:cNvSpPr/>
              <p:nvPr/>
            </p:nvSpPr>
            <p:spPr>
              <a:xfrm>
                <a:off x="1406160" y="4619160"/>
                <a:ext cx="807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R-spondin2</a:t>
                </a:r>
                <a:r>
                  <a:rPr b="0" lang="zh-CN" sz="10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39" name="组 471"/>
            <p:cNvGrpSpPr/>
            <p:nvPr/>
          </p:nvGrpSpPr>
          <p:grpSpPr>
            <a:xfrm>
              <a:off x="1458000" y="5065560"/>
              <a:ext cx="2070360" cy="246240"/>
              <a:chOff x="1458000" y="5065560"/>
              <a:chExt cx="2070360" cy="246240"/>
            </a:xfrm>
          </p:grpSpPr>
          <p:sp>
            <p:nvSpPr>
              <p:cNvPr id="740" name="矩形 478"/>
              <p:cNvSpPr/>
              <p:nvPr/>
            </p:nvSpPr>
            <p:spPr>
              <a:xfrm>
                <a:off x="1458000" y="5121720"/>
                <a:ext cx="2070360" cy="143640"/>
              </a:xfrm>
              <a:prstGeom prst="rect">
                <a:avLst/>
              </a:prstGeom>
              <a:solidFill>
                <a:srgbClr val="fea695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1" name="文本框 236"/>
              <p:cNvSpPr/>
              <p:nvPr/>
            </p:nvSpPr>
            <p:spPr>
              <a:xfrm>
                <a:off x="1998720" y="5065560"/>
                <a:ext cx="963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R-spondin2</a:t>
                </a:r>
                <a:r>
                  <a:rPr b="0" lang="zh-CN" sz="10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42" name="组 490"/>
            <p:cNvGrpSpPr/>
            <p:nvPr/>
          </p:nvGrpSpPr>
          <p:grpSpPr>
            <a:xfrm>
              <a:off x="2091960" y="4765680"/>
              <a:ext cx="807120" cy="246240"/>
              <a:chOff x="2091960" y="4765680"/>
              <a:chExt cx="807120" cy="246240"/>
            </a:xfrm>
          </p:grpSpPr>
          <p:sp>
            <p:nvSpPr>
              <p:cNvPr id="743" name="矩形 491"/>
              <p:cNvSpPr/>
              <p:nvPr/>
            </p:nvSpPr>
            <p:spPr>
              <a:xfrm>
                <a:off x="2157480" y="4826520"/>
                <a:ext cx="684000" cy="146520"/>
              </a:xfrm>
              <a:prstGeom prst="rect">
                <a:avLst/>
              </a:prstGeom>
              <a:solidFill>
                <a:srgbClr val="fea695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4" name="文本框 236"/>
              <p:cNvSpPr/>
              <p:nvPr/>
            </p:nvSpPr>
            <p:spPr>
              <a:xfrm>
                <a:off x="2091960" y="4765680"/>
                <a:ext cx="807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R-spondin2</a:t>
                </a:r>
                <a:r>
                  <a:rPr b="0" lang="zh-CN" sz="10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45" name="组 493"/>
            <p:cNvGrpSpPr/>
            <p:nvPr/>
          </p:nvGrpSpPr>
          <p:grpSpPr>
            <a:xfrm>
              <a:off x="2778840" y="4912200"/>
              <a:ext cx="807120" cy="246240"/>
              <a:chOff x="2778840" y="4912200"/>
              <a:chExt cx="807120" cy="246240"/>
            </a:xfrm>
          </p:grpSpPr>
          <p:sp>
            <p:nvSpPr>
              <p:cNvPr id="746" name="矩形 494"/>
              <p:cNvSpPr/>
              <p:nvPr/>
            </p:nvSpPr>
            <p:spPr>
              <a:xfrm>
                <a:off x="2844360" y="4973040"/>
                <a:ext cx="684000" cy="146520"/>
              </a:xfrm>
              <a:prstGeom prst="rect">
                <a:avLst/>
              </a:prstGeom>
              <a:solidFill>
                <a:srgbClr val="fea695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7" name="文本框 236"/>
              <p:cNvSpPr/>
              <p:nvPr/>
            </p:nvSpPr>
            <p:spPr>
              <a:xfrm>
                <a:off x="2778840" y="4912200"/>
                <a:ext cx="807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R-spondin2</a:t>
                </a:r>
                <a:r>
                  <a:rPr b="0" lang="zh-CN" sz="10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748" name="文本框 688"/>
          <p:cNvSpPr/>
          <p:nvPr/>
        </p:nvSpPr>
        <p:spPr>
          <a:xfrm>
            <a:off x="323280" y="5158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9" name="文本框 688"/>
          <p:cNvSpPr/>
          <p:nvPr/>
        </p:nvSpPr>
        <p:spPr>
          <a:xfrm>
            <a:off x="323280" y="40705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02T03:01:00Z</dcterms:created>
  <dc:creator>yu wang</dc:creator>
  <dc:description/>
  <dc:language>en-US</dc:language>
  <cp:lastModifiedBy>yuwang</cp:lastModifiedBy>
  <dcterms:modified xsi:type="dcterms:W3CDTF">2019-03-25T23:37:40Z</dcterms:modified>
  <cp:revision>246</cp:revision>
  <dc:subject/>
  <dc:title>PowerPoint ʾĸ�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.0.0.1087</vt:lpwstr>
  </property>
</Properties>
</file>